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Honokiol%20monoacetato%2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721473796818057E-2"/>
          <c:y val="2.6646234643437638E-2"/>
          <c:w val="0.86502578646863459"/>
          <c:h val="0.7649637914297085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Graph!$D$24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G$25:$G$39</c:f>
                <c:numCache>
                  <c:formatCode>General</c:formatCode>
                  <c:ptCount val="15"/>
                  <c:pt idx="0">
                    <c:v>5.8257789205057469</c:v>
                  </c:pt>
                  <c:pt idx="1">
                    <c:v>2.2735860399117942</c:v>
                  </c:pt>
                  <c:pt idx="2">
                    <c:v>1.1817110772887045</c:v>
                  </c:pt>
                  <c:pt idx="3">
                    <c:v>2.3906843444704999</c:v>
                  </c:pt>
                  <c:pt idx="4">
                    <c:v>1.0584754935143152</c:v>
                  </c:pt>
                  <c:pt idx="5">
                    <c:v>1.9908629972056073</c:v>
                  </c:pt>
                  <c:pt idx="6">
                    <c:v>6.1352282468564816</c:v>
                  </c:pt>
                  <c:pt idx="7">
                    <c:v>2.3094010767585034</c:v>
                  </c:pt>
                  <c:pt idx="8">
                    <c:v>1.6692660963720432</c:v>
                  </c:pt>
                  <c:pt idx="9">
                    <c:v>1.5688866010587668</c:v>
                  </c:pt>
                  <c:pt idx="10">
                    <c:v>0.76369083226140977</c:v>
                  </c:pt>
                  <c:pt idx="11">
                    <c:v>2.6243194054073866</c:v>
                  </c:pt>
                  <c:pt idx="12">
                    <c:v>0</c:v>
                  </c:pt>
                  <c:pt idx="13">
                    <c:v>3.8960861360456431</c:v>
                  </c:pt>
                  <c:pt idx="14">
                    <c:v>0</c:v>
                  </c:pt>
                </c:numCache>
              </c:numRef>
            </c:plus>
            <c:minus>
              <c:numRef>
                <c:f>Graph!$G$25:$G$39</c:f>
                <c:numCache>
                  <c:formatCode>General</c:formatCode>
                  <c:ptCount val="15"/>
                  <c:pt idx="0">
                    <c:v>5.8257789205057469</c:v>
                  </c:pt>
                  <c:pt idx="1">
                    <c:v>2.2735860399117942</c:v>
                  </c:pt>
                  <c:pt idx="2">
                    <c:v>1.1817110772887045</c:v>
                  </c:pt>
                  <c:pt idx="3">
                    <c:v>2.3906843444704999</c:v>
                  </c:pt>
                  <c:pt idx="4">
                    <c:v>1.0584754935143152</c:v>
                  </c:pt>
                  <c:pt idx="5">
                    <c:v>1.9908629972056073</c:v>
                  </c:pt>
                  <c:pt idx="6">
                    <c:v>6.1352282468564816</c:v>
                  </c:pt>
                  <c:pt idx="7">
                    <c:v>2.3094010767585034</c:v>
                  </c:pt>
                  <c:pt idx="8">
                    <c:v>1.6692660963720432</c:v>
                  </c:pt>
                  <c:pt idx="9">
                    <c:v>1.5688866010587668</c:v>
                  </c:pt>
                  <c:pt idx="10">
                    <c:v>0.76369083226140977</c:v>
                  </c:pt>
                  <c:pt idx="11">
                    <c:v>2.6243194054073866</c:v>
                  </c:pt>
                  <c:pt idx="12">
                    <c:v>0</c:v>
                  </c:pt>
                  <c:pt idx="13">
                    <c:v>3.8960861360456431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Graph!$C$25:$C$39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5:$D$39</c:f>
              <c:numCache>
                <c:formatCode>0.0</c:formatCode>
                <c:ptCount val="15"/>
                <c:pt idx="0">
                  <c:v>50.848484848484844</c:v>
                </c:pt>
                <c:pt idx="1">
                  <c:v>41.334776334776336</c:v>
                </c:pt>
                <c:pt idx="2">
                  <c:v>40.058479532163737</c:v>
                </c:pt>
                <c:pt idx="3">
                  <c:v>39.061421670117333</c:v>
                </c:pt>
                <c:pt idx="4">
                  <c:v>43.277777777777779</c:v>
                </c:pt>
                <c:pt idx="5">
                  <c:v>33.333333333333336</c:v>
                </c:pt>
                <c:pt idx="6">
                  <c:v>62.358974358974358</c:v>
                </c:pt>
                <c:pt idx="7">
                  <c:v>61.333333333333336</c:v>
                </c:pt>
                <c:pt idx="8">
                  <c:v>45.053763440860216</c:v>
                </c:pt>
                <c:pt idx="9">
                  <c:v>64.311594202898547</c:v>
                </c:pt>
                <c:pt idx="10">
                  <c:v>31.305114638447975</c:v>
                </c:pt>
                <c:pt idx="11">
                  <c:v>46.262626262626263</c:v>
                </c:pt>
                <c:pt idx="12">
                  <c:v>37.777777777777779</c:v>
                </c:pt>
                <c:pt idx="13">
                  <c:v>20.871794871794872</c:v>
                </c:pt>
                <c:pt idx="14">
                  <c:v>43.4782608695652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461-4BCB-B711-96CCF871A8E9}"/>
            </c:ext>
          </c:extLst>
        </c:ser>
        <c:ser>
          <c:idx val="6"/>
          <c:order val="1"/>
          <c:tx>
            <c:strRef>
              <c:f>Graph!$F$24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FF33CC"/>
            </a:solidFill>
            <a:ln>
              <a:solidFill>
                <a:srgbClr val="FF33CC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33CC"/>
              </a:solidFill>
              <a:ln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3E58-4304-97DD-F0971899E016}"/>
              </c:ext>
            </c:extLst>
          </c:dPt>
          <c:errBars>
            <c:errBarType val="both"/>
            <c:errValType val="cust"/>
            <c:noEndCap val="0"/>
            <c:plus>
              <c:numRef>
                <c:f>Graph!$K$25:$K$38</c:f>
                <c:numCache>
                  <c:formatCode>General</c:formatCode>
                  <c:ptCount val="14"/>
                  <c:pt idx="0">
                    <c:v>5.590341051321901</c:v>
                  </c:pt>
                  <c:pt idx="1">
                    <c:v>6.2537383483819182</c:v>
                  </c:pt>
                  <c:pt idx="2">
                    <c:v>1.0128952091046026</c:v>
                  </c:pt>
                  <c:pt idx="3">
                    <c:v>1.7930132583528668</c:v>
                  </c:pt>
                  <c:pt idx="4">
                    <c:v>0.57735026918962573</c:v>
                  </c:pt>
                  <c:pt idx="5">
                    <c:v>0</c:v>
                  </c:pt>
                  <c:pt idx="6">
                    <c:v>0.355292473347469</c:v>
                  </c:pt>
                  <c:pt idx="7">
                    <c:v>0</c:v>
                  </c:pt>
                  <c:pt idx="8">
                    <c:v>0.49664539285128234</c:v>
                  </c:pt>
                  <c:pt idx="9">
                    <c:v>0.52296220035292507</c:v>
                  </c:pt>
                  <c:pt idx="10">
                    <c:v>1.834448330045388</c:v>
                  </c:pt>
                  <c:pt idx="11">
                    <c:v>4.1989110486518202</c:v>
                  </c:pt>
                  <c:pt idx="12">
                    <c:v>1.9245008972987498</c:v>
                  </c:pt>
                  <c:pt idx="13">
                    <c:v>1.5099930117267122</c:v>
                  </c:pt>
                </c:numCache>
              </c:numRef>
            </c:plus>
            <c:minus>
              <c:numRef>
                <c:f>Graph!$K$25:$K$39</c:f>
                <c:numCache>
                  <c:formatCode>General</c:formatCode>
                  <c:ptCount val="15"/>
                  <c:pt idx="0">
                    <c:v>5.590341051321901</c:v>
                  </c:pt>
                  <c:pt idx="1">
                    <c:v>6.2537383483819182</c:v>
                  </c:pt>
                  <c:pt idx="2">
                    <c:v>1.0128952091046026</c:v>
                  </c:pt>
                  <c:pt idx="3">
                    <c:v>1.7930132583528668</c:v>
                  </c:pt>
                  <c:pt idx="4">
                    <c:v>0.57735026918962573</c:v>
                  </c:pt>
                  <c:pt idx="5">
                    <c:v>0</c:v>
                  </c:pt>
                  <c:pt idx="6">
                    <c:v>0.355292473347469</c:v>
                  </c:pt>
                  <c:pt idx="7">
                    <c:v>0</c:v>
                  </c:pt>
                  <c:pt idx="8">
                    <c:v>0.49664539285128234</c:v>
                  </c:pt>
                  <c:pt idx="9">
                    <c:v>0.52296220035292507</c:v>
                  </c:pt>
                  <c:pt idx="10">
                    <c:v>1.834448330045388</c:v>
                  </c:pt>
                  <c:pt idx="11">
                    <c:v>4.1989110486518202</c:v>
                  </c:pt>
                  <c:pt idx="12">
                    <c:v>1.9245008972987498</c:v>
                  </c:pt>
                  <c:pt idx="13">
                    <c:v>1.5099930117267122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Graph!$C$25:$C$39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5:$F$39</c:f>
              <c:numCache>
                <c:formatCode>0.0</c:formatCode>
                <c:ptCount val="15"/>
                <c:pt idx="0">
                  <c:v>57.98989898989899</c:v>
                </c:pt>
                <c:pt idx="1">
                  <c:v>47.691197691197694</c:v>
                </c:pt>
                <c:pt idx="2">
                  <c:v>38.20662768031189</c:v>
                </c:pt>
                <c:pt idx="3">
                  <c:v>44.858523119392686</c:v>
                </c:pt>
                <c:pt idx="4">
                  <c:v>44.611111111111121</c:v>
                </c:pt>
                <c:pt idx="5">
                  <c:v>42.52873563218391</c:v>
                </c:pt>
                <c:pt idx="6">
                  <c:v>58.410256410256409</c:v>
                </c:pt>
                <c:pt idx="7">
                  <c:v>65.333333333333329</c:v>
                </c:pt>
                <c:pt idx="8">
                  <c:v>45.053763440860216</c:v>
                </c:pt>
                <c:pt idx="9">
                  <c:v>64.311594202898547</c:v>
                </c:pt>
                <c:pt idx="10">
                  <c:v>36.155202821869494</c:v>
                </c:pt>
                <c:pt idx="11">
                  <c:v>48.484848484848492</c:v>
                </c:pt>
                <c:pt idx="12">
                  <c:v>40</c:v>
                </c:pt>
                <c:pt idx="13">
                  <c:v>27.282051282051281</c:v>
                </c:pt>
                <c:pt idx="14">
                  <c:v>43.4782608695652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461-4BCB-B711-96CCF871A8E9}"/>
            </c:ext>
          </c:extLst>
        </c:ser>
        <c:ser>
          <c:idx val="1"/>
          <c:order val="2"/>
          <c:tx>
            <c:strRef>
              <c:f>Graph!$H$24</c:f>
              <c:strCache>
                <c:ptCount val="1"/>
                <c:pt idx="0">
                  <c:v>25 µg/ml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!$C$25:$C$39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5:$H$39</c:f>
              <c:numCache>
                <c:formatCode>0.0</c:formatCode>
                <c:ptCount val="15"/>
                <c:pt idx="0">
                  <c:v>76.328282828282838</c:v>
                </c:pt>
                <c:pt idx="1">
                  <c:v>61.926406926406919</c:v>
                </c:pt>
                <c:pt idx="2">
                  <c:v>60.03898635477583</c:v>
                </c:pt>
                <c:pt idx="3">
                  <c:v>62.801932367149753</c:v>
                </c:pt>
                <c:pt idx="4">
                  <c:v>60.833333333333336</c:v>
                </c:pt>
                <c:pt idx="5">
                  <c:v>62.068965517241374</c:v>
                </c:pt>
                <c:pt idx="6">
                  <c:v>72.717948717948715</c:v>
                </c:pt>
                <c:pt idx="7">
                  <c:v>82.666666666666671</c:v>
                </c:pt>
                <c:pt idx="8">
                  <c:v>59.354838709677416</c:v>
                </c:pt>
                <c:pt idx="9">
                  <c:v>71.437198067632849</c:v>
                </c:pt>
                <c:pt idx="10">
                  <c:v>59.082892416225754</c:v>
                </c:pt>
                <c:pt idx="11">
                  <c:v>67.878787878787875</c:v>
                </c:pt>
                <c:pt idx="12">
                  <c:v>56.666666666666664</c:v>
                </c:pt>
                <c:pt idx="13">
                  <c:v>54.564102564102562</c:v>
                </c:pt>
                <c:pt idx="14">
                  <c:v>55.0724637681159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461-4BCB-B711-96CCF871A8E9}"/>
            </c:ext>
          </c:extLst>
        </c:ser>
        <c:ser>
          <c:idx val="5"/>
          <c:order val="3"/>
          <c:tx>
            <c:strRef>
              <c:f>Graph!$J$24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5:$K$39</c:f>
                <c:numCache>
                  <c:formatCode>General</c:formatCode>
                  <c:ptCount val="15"/>
                  <c:pt idx="0">
                    <c:v>5.590341051321901</c:v>
                  </c:pt>
                  <c:pt idx="1">
                    <c:v>6.2537383483819182</c:v>
                  </c:pt>
                  <c:pt idx="2">
                    <c:v>1.0128952091046026</c:v>
                  </c:pt>
                  <c:pt idx="3">
                    <c:v>1.7930132583528668</c:v>
                  </c:pt>
                  <c:pt idx="4">
                    <c:v>0.57735026918962573</c:v>
                  </c:pt>
                  <c:pt idx="5">
                    <c:v>0</c:v>
                  </c:pt>
                  <c:pt idx="6">
                    <c:v>0.355292473347469</c:v>
                  </c:pt>
                  <c:pt idx="7">
                    <c:v>0</c:v>
                  </c:pt>
                  <c:pt idx="8">
                    <c:v>0.49664539285128234</c:v>
                  </c:pt>
                  <c:pt idx="9">
                    <c:v>0.52296220035292507</c:v>
                  </c:pt>
                  <c:pt idx="10">
                    <c:v>1.834448330045388</c:v>
                  </c:pt>
                  <c:pt idx="11">
                    <c:v>4.1989110486518202</c:v>
                  </c:pt>
                  <c:pt idx="12">
                    <c:v>1.9245008972987498</c:v>
                  </c:pt>
                  <c:pt idx="13">
                    <c:v>1.5099930117267122</c:v>
                  </c:pt>
                  <c:pt idx="14">
                    <c:v>0</c:v>
                  </c:pt>
                </c:numCache>
              </c:numRef>
            </c:plus>
            <c:minus>
              <c:numRef>
                <c:f>Graph!$K$25:$K$39</c:f>
                <c:numCache>
                  <c:formatCode>General</c:formatCode>
                  <c:ptCount val="15"/>
                  <c:pt idx="0">
                    <c:v>5.590341051321901</c:v>
                  </c:pt>
                  <c:pt idx="1">
                    <c:v>6.2537383483819182</c:v>
                  </c:pt>
                  <c:pt idx="2">
                    <c:v>1.0128952091046026</c:v>
                  </c:pt>
                  <c:pt idx="3">
                    <c:v>1.7930132583528668</c:v>
                  </c:pt>
                  <c:pt idx="4">
                    <c:v>0.57735026918962573</c:v>
                  </c:pt>
                  <c:pt idx="5">
                    <c:v>0</c:v>
                  </c:pt>
                  <c:pt idx="6">
                    <c:v>0.355292473347469</c:v>
                  </c:pt>
                  <c:pt idx="7">
                    <c:v>0</c:v>
                  </c:pt>
                  <c:pt idx="8">
                    <c:v>0.49664539285128234</c:v>
                  </c:pt>
                  <c:pt idx="9">
                    <c:v>0.52296220035292507</c:v>
                  </c:pt>
                  <c:pt idx="10">
                    <c:v>1.834448330045388</c:v>
                  </c:pt>
                  <c:pt idx="11">
                    <c:v>4.1989110486518202</c:v>
                  </c:pt>
                  <c:pt idx="12">
                    <c:v>1.9245008972987498</c:v>
                  </c:pt>
                  <c:pt idx="13">
                    <c:v>1.5099930117267122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Graph!$C$25:$C$39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5:$J$39</c:f>
              <c:numCache>
                <c:formatCode>0.0</c:formatCode>
                <c:ptCount val="15"/>
                <c:pt idx="0">
                  <c:v>84.747474747474755</c:v>
                </c:pt>
                <c:pt idx="1">
                  <c:v>79.559884559884566</c:v>
                </c:pt>
                <c:pt idx="2">
                  <c:v>67.251461988304087</c:v>
                </c:pt>
                <c:pt idx="3">
                  <c:v>83.643892339544507</c:v>
                </c:pt>
                <c:pt idx="4">
                  <c:v>75.666666666666671</c:v>
                </c:pt>
                <c:pt idx="5">
                  <c:v>68.965517241379317</c:v>
                </c:pt>
                <c:pt idx="6">
                  <c:v>84.410256410256423</c:v>
                </c:pt>
                <c:pt idx="7">
                  <c:v>91.999999999999986</c:v>
                </c:pt>
                <c:pt idx="8">
                  <c:v>73.620071684587813</c:v>
                </c:pt>
                <c:pt idx="9">
                  <c:v>78.562801932367151</c:v>
                </c:pt>
                <c:pt idx="10">
                  <c:v>69.885361552028215</c:v>
                </c:pt>
                <c:pt idx="11">
                  <c:v>77.575757575757578</c:v>
                </c:pt>
                <c:pt idx="12">
                  <c:v>68.8888888888889</c:v>
                </c:pt>
                <c:pt idx="13">
                  <c:v>66.256410256410263</c:v>
                </c:pt>
                <c:pt idx="14">
                  <c:v>73.9130434782608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461-4BCB-B711-96CCF871A8E9}"/>
            </c:ext>
          </c:extLst>
        </c:ser>
        <c:ser>
          <c:idx val="9"/>
          <c:order val="4"/>
          <c:tx>
            <c:strRef>
              <c:f>Graph!$L$24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!$M$25:$M$39</c:f>
                <c:numCache>
                  <c:formatCode>General</c:formatCode>
                  <c:ptCount val="15"/>
                  <c:pt idx="0">
                    <c:v>4.4172925211059528</c:v>
                  </c:pt>
                  <c:pt idx="1">
                    <c:v>6.698087999675419</c:v>
                  </c:pt>
                  <c:pt idx="2">
                    <c:v>7.6936338681738299</c:v>
                  </c:pt>
                  <c:pt idx="3">
                    <c:v>8.0087925539761518</c:v>
                  </c:pt>
                  <c:pt idx="4">
                    <c:v>2.5980762113533076</c:v>
                  </c:pt>
                  <c:pt idx="5">
                    <c:v>0</c:v>
                  </c:pt>
                  <c:pt idx="6">
                    <c:v>4.3523327985064144</c:v>
                  </c:pt>
                  <c:pt idx="7">
                    <c:v>2.3094010767585114</c:v>
                  </c:pt>
                  <c:pt idx="8">
                    <c:v>2.097003939255925</c:v>
                  </c:pt>
                  <c:pt idx="9">
                    <c:v>2.51021856169403</c:v>
                  </c:pt>
                  <c:pt idx="10">
                    <c:v>1.9092270806535141</c:v>
                  </c:pt>
                  <c:pt idx="11">
                    <c:v>2.4493647783802346</c:v>
                  </c:pt>
                  <c:pt idx="12">
                    <c:v>5.0917507721731559</c:v>
                  </c:pt>
                  <c:pt idx="13">
                    <c:v>3.769492403269143</c:v>
                  </c:pt>
                  <c:pt idx="14">
                    <c:v>2.51021856169403</c:v>
                  </c:pt>
                </c:numCache>
              </c:numRef>
            </c:plus>
            <c:minus>
              <c:numRef>
                <c:f>Graph!$M$25:$M$39</c:f>
                <c:numCache>
                  <c:formatCode>General</c:formatCode>
                  <c:ptCount val="15"/>
                  <c:pt idx="0">
                    <c:v>4.4172925211059528</c:v>
                  </c:pt>
                  <c:pt idx="1">
                    <c:v>6.698087999675419</c:v>
                  </c:pt>
                  <c:pt idx="2">
                    <c:v>7.6936338681738299</c:v>
                  </c:pt>
                  <c:pt idx="3">
                    <c:v>8.0087925539761518</c:v>
                  </c:pt>
                  <c:pt idx="4">
                    <c:v>2.5980762113533076</c:v>
                  </c:pt>
                  <c:pt idx="5">
                    <c:v>0</c:v>
                  </c:pt>
                  <c:pt idx="6">
                    <c:v>4.3523327985064144</c:v>
                  </c:pt>
                  <c:pt idx="7">
                    <c:v>2.3094010767585114</c:v>
                  </c:pt>
                  <c:pt idx="8">
                    <c:v>2.097003939255925</c:v>
                  </c:pt>
                  <c:pt idx="9">
                    <c:v>2.51021856169403</c:v>
                  </c:pt>
                  <c:pt idx="10">
                    <c:v>1.9092270806535141</c:v>
                  </c:pt>
                  <c:pt idx="11">
                    <c:v>2.4493647783802346</c:v>
                  </c:pt>
                  <c:pt idx="12">
                    <c:v>5.0917507721731559</c:v>
                  </c:pt>
                  <c:pt idx="13">
                    <c:v>3.769492403269143</c:v>
                  </c:pt>
                  <c:pt idx="14">
                    <c:v>2.51021856169403</c:v>
                  </c:pt>
                </c:numCache>
              </c:numRef>
            </c:minus>
          </c:errBars>
          <c:cat>
            <c:strRef>
              <c:f>Graph!$C$25:$C$39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5:$L$39</c:f>
              <c:numCache>
                <c:formatCode>0.0</c:formatCode>
                <c:ptCount val="15"/>
                <c:pt idx="0">
                  <c:v>93.095959595959599</c:v>
                </c:pt>
                <c:pt idx="1">
                  <c:v>89.098124098124103</c:v>
                </c:pt>
                <c:pt idx="2">
                  <c:v>81.968810916179336</c:v>
                </c:pt>
                <c:pt idx="3">
                  <c:v>100.2760524499655</c:v>
                </c:pt>
                <c:pt idx="4">
                  <c:v>90.5</c:v>
                </c:pt>
                <c:pt idx="5">
                  <c:v>86.206896551724142</c:v>
                </c:pt>
                <c:pt idx="6">
                  <c:v>90.974358974358964</c:v>
                </c:pt>
                <c:pt idx="7">
                  <c:v>94.666666666666671</c:v>
                </c:pt>
                <c:pt idx="8">
                  <c:v>82.401433691756267</c:v>
                </c:pt>
                <c:pt idx="9">
                  <c:v>102.89855072463769</c:v>
                </c:pt>
                <c:pt idx="10">
                  <c:v>90.388007054673722</c:v>
                </c:pt>
                <c:pt idx="11">
                  <c:v>88.080808080808083</c:v>
                </c:pt>
                <c:pt idx="12">
                  <c:v>94.444444444444443</c:v>
                </c:pt>
                <c:pt idx="13">
                  <c:v>92.256410256410263</c:v>
                </c:pt>
                <c:pt idx="14">
                  <c:v>89.855072463768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461-4BCB-B711-96CCF871A8E9}"/>
            </c:ext>
          </c:extLst>
        </c:ser>
        <c:ser>
          <c:idx val="0"/>
          <c:order val="5"/>
          <c:tx>
            <c:strRef>
              <c:f>Graph!$N$24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N$25:$N$39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E58-4304-97DD-F0971899E0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8759088"/>
        <c:axId val="348758696"/>
      </c:barChart>
      <c:catAx>
        <c:axId val="348759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  <c:crossAx val="348758696"/>
        <c:crosses val="autoZero"/>
        <c:auto val="1"/>
        <c:lblAlgn val="ctr"/>
        <c:lblOffset val="100"/>
        <c:noMultiLvlLbl val="0"/>
      </c:catAx>
      <c:valAx>
        <c:axId val="348758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 diameter (% relative to control) </a:t>
                </a:r>
              </a:p>
            </c:rich>
          </c:tx>
          <c:layout>
            <c:manualLayout>
              <c:xMode val="edge"/>
              <c:yMode val="edge"/>
              <c:x val="4.7751613986640297E-3"/>
              <c:y val="0.2812348480058320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4875908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3602</cdr:x>
      <cdr:y>0.19556</cdr:y>
    </cdr:from>
    <cdr:to>
      <cdr:x>0.05592</cdr:x>
      <cdr:y>0.24232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361950" y="1314450"/>
          <a:ext cx="2000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4835</cdr:x>
      <cdr:y>0.39112</cdr:y>
    </cdr:from>
    <cdr:to>
      <cdr:x>0.06256</cdr:x>
      <cdr:y>0.43363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485820" y="2628909"/>
          <a:ext cx="142795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5498</cdr:x>
      <cdr:y>0.3486</cdr:y>
    </cdr:from>
    <cdr:to>
      <cdr:x>0.0692</cdr:x>
      <cdr:y>0.3897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552466" y="2343131"/>
          <a:ext cx="142895" cy="2762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6256</cdr:x>
      <cdr:y>0.26075</cdr:y>
    </cdr:from>
    <cdr:to>
      <cdr:x>0.07678</cdr:x>
      <cdr:y>0.30185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628615" y="1752604"/>
          <a:ext cx="142895" cy="2762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654</cdr:x>
      <cdr:y>0.15305</cdr:y>
    </cdr:from>
    <cdr:to>
      <cdr:x>0.10521</cdr:x>
      <cdr:y>0.21823</cdr:y>
    </cdr:to>
    <cdr:sp macro="" textlink="">
      <cdr:nvSpPr>
        <cdr:cNvPr id="6" name="CasellaDiTesto 5"/>
        <cdr:cNvSpPr txBox="1"/>
      </cdr:nvSpPr>
      <cdr:spPr>
        <a:xfrm xmlns:a="http://schemas.openxmlformats.org/drawingml/2006/main" rot="16200000">
          <a:off x="638189" y="1047754"/>
          <a:ext cx="438105" cy="4000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07346</cdr:x>
      <cdr:y>0.12258</cdr:y>
    </cdr:from>
    <cdr:to>
      <cdr:x>0.1199</cdr:x>
      <cdr:y>0.17076</cdr:y>
    </cdr:to>
    <cdr:sp macro="" textlink="">
      <cdr:nvSpPr>
        <cdr:cNvPr id="7" name="CasellaDiTesto 6"/>
        <cdr:cNvSpPr txBox="1"/>
      </cdr:nvSpPr>
      <cdr:spPr>
        <a:xfrm xmlns:a="http://schemas.openxmlformats.org/drawingml/2006/main" rot="16200000">
          <a:off x="809627" y="752496"/>
          <a:ext cx="323841" cy="4666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0853</cdr:x>
      <cdr:y>0.1162</cdr:y>
    </cdr:from>
    <cdr:to>
      <cdr:x>0.10521</cdr:x>
      <cdr:y>0.15871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857204" y="781052"/>
          <a:ext cx="200073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0332</cdr:x>
      <cdr:y>0.47331</cdr:y>
    </cdr:from>
    <cdr:to>
      <cdr:x>0.11943</cdr:x>
      <cdr:y>0.52291</cdr:y>
    </cdr:to>
    <cdr:sp macro="" textlink="">
      <cdr:nvSpPr>
        <cdr:cNvPr id="9" name="CasellaDiTesto 8"/>
        <cdr:cNvSpPr txBox="1"/>
      </cdr:nvSpPr>
      <cdr:spPr>
        <a:xfrm xmlns:a="http://schemas.openxmlformats.org/drawingml/2006/main" flipH="1">
          <a:off x="1038271" y="3181343"/>
          <a:ext cx="161888" cy="3333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0711</cdr:x>
      <cdr:y>0.35144</cdr:y>
    </cdr:from>
    <cdr:to>
      <cdr:x>0.13839</cdr:x>
      <cdr:y>0.44922</cdr:y>
    </cdr:to>
    <cdr:sp macro="" textlink="">
      <cdr:nvSpPr>
        <cdr:cNvPr id="10" name="CasellaDiTesto 9"/>
        <cdr:cNvSpPr txBox="1"/>
      </cdr:nvSpPr>
      <cdr:spPr>
        <a:xfrm xmlns:a="http://schemas.openxmlformats.org/drawingml/2006/main" rot="16200000">
          <a:off x="904910" y="2533629"/>
          <a:ext cx="657226" cy="3143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d</a:t>
          </a:r>
        </a:p>
      </cdr:txBody>
    </cdr:sp>
  </cdr:relSizeAnchor>
  <cdr:relSizeAnchor xmlns:cdr="http://schemas.openxmlformats.org/drawingml/2006/chartDrawing">
    <cdr:from>
      <cdr:x>0.11943</cdr:x>
      <cdr:y>0.35427</cdr:y>
    </cdr:from>
    <cdr:to>
      <cdr:x>0.13933</cdr:x>
      <cdr:y>0.42229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200159" y="2381242"/>
          <a:ext cx="199972" cy="4571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2606</cdr:x>
      <cdr:y>0.2069</cdr:y>
    </cdr:from>
    <cdr:to>
      <cdr:x>0.14407</cdr:x>
      <cdr:y>0.24516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266783" y="1390652"/>
          <a:ext cx="180980" cy="2571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3128</cdr:x>
      <cdr:y>0.1325</cdr:y>
    </cdr:from>
    <cdr:to>
      <cdr:x>0.15498</cdr:x>
      <cdr:y>0.18068</cdr:y>
    </cdr:to>
    <cdr:sp macro="" textlink="">
      <cdr:nvSpPr>
        <cdr:cNvPr id="13" name="CasellaDiTesto 12"/>
        <cdr:cNvSpPr txBox="1"/>
      </cdr:nvSpPr>
      <cdr:spPr>
        <a:xfrm xmlns:a="http://schemas.openxmlformats.org/drawingml/2006/main" rot="16200000">
          <a:off x="1276382" y="933457"/>
          <a:ext cx="323840" cy="2381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14218</cdr:x>
      <cdr:y>0.11195</cdr:y>
    </cdr:from>
    <cdr:to>
      <cdr:x>0.17061</cdr:x>
      <cdr:y>0.16013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1428769" y="752485"/>
          <a:ext cx="285690" cy="3238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6019</cdr:x>
      <cdr:y>0.49032</cdr:y>
    </cdr:from>
    <cdr:to>
      <cdr:x>0.21137</cdr:x>
      <cdr:y>0.53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1609772" y="3295666"/>
          <a:ext cx="514302" cy="2667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17536</cdr:x>
      <cdr:y>0.36419</cdr:y>
    </cdr:from>
    <cdr:to>
      <cdr:x>0.19621</cdr:x>
      <cdr:y>0.40387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1762171" y="2447897"/>
          <a:ext cx="209519" cy="2667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8294</cdr:x>
      <cdr:y>0.3146</cdr:y>
    </cdr:from>
    <cdr:to>
      <cdr:x>0.20663</cdr:x>
      <cdr:y>0.37128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1838326" y="2114550"/>
          <a:ext cx="238110" cy="381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9147</cdr:x>
      <cdr:y>0.18139</cdr:y>
    </cdr:from>
    <cdr:to>
      <cdr:x>0.2199</cdr:x>
      <cdr:y>0.22957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1924065" y="1219218"/>
          <a:ext cx="285689" cy="3238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</cdr:x>
      <cdr:y>0.1162</cdr:y>
    </cdr:from>
    <cdr:to>
      <cdr:x>0.2256</cdr:x>
      <cdr:y>0.14313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2009737" y="781048"/>
          <a:ext cx="257252" cy="1810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896</cdr:x>
      <cdr:y>0.49031</cdr:y>
    </cdr:from>
    <cdr:to>
      <cdr:x>0.23791</cdr:x>
      <cdr:y>0.52291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2200308" y="3295625"/>
          <a:ext cx="190427" cy="2191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2512</cdr:x>
      <cdr:y>0.44426</cdr:y>
    </cdr:from>
    <cdr:to>
      <cdr:x>0.25735</cdr:x>
      <cdr:y>0.49669</cdr:y>
    </cdr:to>
    <cdr:sp macro="" textlink="">
      <cdr:nvSpPr>
        <cdr:cNvPr id="21" name="CasellaDiTesto 20"/>
        <cdr:cNvSpPr txBox="1"/>
      </cdr:nvSpPr>
      <cdr:spPr>
        <a:xfrm xmlns:a="http://schemas.openxmlformats.org/drawingml/2006/main" rot="16200000">
          <a:off x="2247945" y="3000361"/>
          <a:ext cx="352407" cy="3238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23222</cdr:x>
      <cdr:y>0.34294</cdr:y>
    </cdr:from>
    <cdr:to>
      <cdr:x>0.25118</cdr:x>
      <cdr:y>0.39396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2333578" y="2305051"/>
          <a:ext cx="190527" cy="3429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4076</cdr:x>
      <cdr:y>0.20407</cdr:y>
    </cdr:from>
    <cdr:to>
      <cdr:x>0.25972</cdr:x>
      <cdr:y>0.23949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419352" y="1371622"/>
          <a:ext cx="190527" cy="238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5024</cdr:x>
      <cdr:y>0.06519</cdr:y>
    </cdr:from>
    <cdr:to>
      <cdr:x>0.27962</cdr:x>
      <cdr:y>0.1077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514637" y="438156"/>
          <a:ext cx="295236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7583</cdr:x>
      <cdr:y>0.46481</cdr:y>
    </cdr:from>
    <cdr:to>
      <cdr:x>0.3109</cdr:x>
      <cdr:y>0.52574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2771773" y="3124201"/>
          <a:ext cx="352414" cy="4095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 e</a:t>
          </a:r>
        </a:p>
      </cdr:txBody>
    </cdr:sp>
  </cdr:relSizeAnchor>
  <cdr:relSizeAnchor xmlns:cdr="http://schemas.openxmlformats.org/drawingml/2006/chartDrawing">
    <cdr:from>
      <cdr:x>0.291</cdr:x>
      <cdr:y>0.35569</cdr:y>
    </cdr:from>
    <cdr:to>
      <cdr:x>0.31469</cdr:x>
      <cdr:y>0.41238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2924214" y="2390765"/>
          <a:ext cx="238085" cy="3810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9858</cdr:x>
      <cdr:y>0.265</cdr:y>
    </cdr:from>
    <cdr:to>
      <cdr:x>0.31848</cdr:x>
      <cdr:y>0.29759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3000385" y="1781170"/>
          <a:ext cx="199973" cy="2190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0521</cdr:x>
      <cdr:y>0.15871</cdr:y>
    </cdr:from>
    <cdr:to>
      <cdr:x>0.33934</cdr:x>
      <cdr:y>0.19697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3067030" y="1066794"/>
          <a:ext cx="342969" cy="2571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1564</cdr:x>
      <cdr:y>0.11195</cdr:y>
    </cdr:from>
    <cdr:to>
      <cdr:x>0.34881</cdr:x>
      <cdr:y>0.14312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3171875" y="752487"/>
          <a:ext cx="333321" cy="2095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3554</cdr:x>
      <cdr:y>0.52858</cdr:y>
    </cdr:from>
    <cdr:to>
      <cdr:x>0.35166</cdr:x>
      <cdr:y>0.57251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3371834" y="3552817"/>
          <a:ext cx="161988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f</a:t>
          </a:r>
        </a:p>
      </cdr:txBody>
    </cdr:sp>
  </cdr:relSizeAnchor>
  <cdr:relSizeAnchor xmlns:cdr="http://schemas.openxmlformats.org/drawingml/2006/chartDrawing">
    <cdr:from>
      <cdr:x>0.34028</cdr:x>
      <cdr:y>0.47898</cdr:y>
    </cdr:from>
    <cdr:to>
      <cdr:x>0.35924</cdr:x>
      <cdr:y>0.52291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3419466" y="3219456"/>
          <a:ext cx="190527" cy="2952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34976</cdr:x>
      <cdr:y>0.34577</cdr:y>
    </cdr:from>
    <cdr:to>
      <cdr:x>0.36493</cdr:x>
      <cdr:y>0.3812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514708" y="2324092"/>
          <a:ext cx="152441" cy="2381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735</cdr:x>
      <cdr:y>0.31176</cdr:y>
    </cdr:from>
    <cdr:to>
      <cdr:x>0.37536</cdr:x>
      <cdr:y>0.35286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590957" y="2095503"/>
          <a:ext cx="180981" cy="2762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6304</cdr:x>
      <cdr:y>0.1984</cdr:y>
    </cdr:from>
    <cdr:to>
      <cdr:x>0.39052</cdr:x>
      <cdr:y>0.25225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648121" y="1333513"/>
          <a:ext cx="276143" cy="361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7441</cdr:x>
      <cdr:y>0.11337</cdr:y>
    </cdr:from>
    <cdr:to>
      <cdr:x>0.4019</cdr:x>
      <cdr:y>0.1488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3762405" y="762004"/>
          <a:ext cx="276243" cy="2381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005</cdr:x>
      <cdr:y>0.29263</cdr:y>
    </cdr:from>
    <cdr:to>
      <cdr:x>0.43555</cdr:x>
      <cdr:y>0.35357</cdr:y>
    </cdr:to>
    <cdr:sp macro="" textlink="">
      <cdr:nvSpPr>
        <cdr:cNvPr id="36" name="CasellaDiTesto 35"/>
        <cdr:cNvSpPr txBox="1"/>
      </cdr:nvSpPr>
      <cdr:spPr>
        <a:xfrm xmlns:a="http://schemas.openxmlformats.org/drawingml/2006/main" rot="16200000">
          <a:off x="3943350" y="1943076"/>
          <a:ext cx="409606" cy="4572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d</a:t>
          </a:r>
        </a:p>
      </cdr:txBody>
    </cdr:sp>
  </cdr:relSizeAnchor>
  <cdr:relSizeAnchor xmlns:cdr="http://schemas.openxmlformats.org/drawingml/2006/chartDrawing">
    <cdr:from>
      <cdr:x>0.40094</cdr:x>
      <cdr:y>0.3642</cdr:y>
    </cdr:from>
    <cdr:to>
      <cdr:x>0.42085</cdr:x>
      <cdr:y>0.40671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4029031" y="2447930"/>
          <a:ext cx="200073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40569</cdr:x>
      <cdr:y>0.27775</cdr:y>
    </cdr:from>
    <cdr:to>
      <cdr:x>0.42559</cdr:x>
      <cdr:y>0.32026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4076748" y="1866888"/>
          <a:ext cx="199973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1232</cdr:x>
      <cdr:y>0.21256</cdr:y>
    </cdr:from>
    <cdr:to>
      <cdr:x>0.43602</cdr:x>
      <cdr:y>0.25933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4143351" y="1428735"/>
          <a:ext cx="238158" cy="3143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2038</cdr:x>
      <cdr:y>0.12541</cdr:y>
    </cdr:from>
    <cdr:to>
      <cdr:x>0.45924</cdr:x>
      <cdr:y>0.18493</cdr:y>
    </cdr:to>
    <cdr:sp macro="" textlink="">
      <cdr:nvSpPr>
        <cdr:cNvPr id="40" name="CasellaDiTesto 39"/>
        <cdr:cNvSpPr txBox="1"/>
      </cdr:nvSpPr>
      <cdr:spPr>
        <a:xfrm xmlns:a="http://schemas.openxmlformats.org/drawingml/2006/main" rot="16200000">
          <a:off x="4219543" y="847713"/>
          <a:ext cx="400062" cy="3904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3034</cdr:x>
      <cdr:y>0.11195</cdr:y>
    </cdr:from>
    <cdr:to>
      <cdr:x>0.45688</cdr:x>
      <cdr:y>0.15163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4324387" y="752479"/>
          <a:ext cx="266697" cy="2667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644</cdr:x>
      <cdr:y>0.33302</cdr:y>
    </cdr:from>
    <cdr:to>
      <cdr:x>0.49289</cdr:x>
      <cdr:y>0.39962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4486261" y="2238400"/>
          <a:ext cx="466770" cy="4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46351</cdr:x>
      <cdr:y>0.21682</cdr:y>
    </cdr:from>
    <cdr:to>
      <cdr:x>0.48341</cdr:x>
      <cdr:y>0.25225</cdr:y>
    </cdr:to>
    <cdr:sp macro="" textlink="">
      <cdr:nvSpPr>
        <cdr:cNvPr id="43" name="CasellaDiTesto 42"/>
        <cdr:cNvSpPr txBox="1"/>
      </cdr:nvSpPr>
      <cdr:spPr>
        <a:xfrm xmlns:a="http://schemas.openxmlformats.org/drawingml/2006/main">
          <a:off x="4657753" y="1457321"/>
          <a:ext cx="199972" cy="2381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c</a:t>
          </a:r>
        </a:p>
      </cdr:txBody>
    </cdr:sp>
  </cdr:relSizeAnchor>
  <cdr:relSizeAnchor xmlns:cdr="http://schemas.openxmlformats.org/drawingml/2006/chartDrawing">
    <cdr:from>
      <cdr:x>0.47204</cdr:x>
      <cdr:y>0.1658</cdr:y>
    </cdr:from>
    <cdr:to>
      <cdr:x>0.4891</cdr:x>
      <cdr:y>0.19697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4743470" y="1114441"/>
          <a:ext cx="171433" cy="2095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7394</cdr:x>
      <cdr:y>0.10912</cdr:y>
    </cdr:from>
    <cdr:to>
      <cdr:x>0.50806</cdr:x>
      <cdr:y>0.17714</cdr:y>
    </cdr:to>
    <cdr:sp macro="" textlink="">
      <cdr:nvSpPr>
        <cdr:cNvPr id="45" name="CasellaDiTesto 44"/>
        <cdr:cNvSpPr txBox="1"/>
      </cdr:nvSpPr>
      <cdr:spPr>
        <a:xfrm xmlns:a="http://schemas.openxmlformats.org/drawingml/2006/main" rot="16200000">
          <a:off x="4705369" y="790612"/>
          <a:ext cx="457195" cy="3428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872</cdr:x>
      <cdr:y>0.11053</cdr:y>
    </cdr:from>
    <cdr:to>
      <cdr:x>0.51848</cdr:x>
      <cdr:y>0.14879</cdr:y>
    </cdr:to>
    <cdr:sp macro="" textlink="">
      <cdr:nvSpPr>
        <cdr:cNvPr id="46" name="CasellaDiTesto 45"/>
        <cdr:cNvSpPr txBox="1"/>
      </cdr:nvSpPr>
      <cdr:spPr>
        <a:xfrm xmlns:a="http://schemas.openxmlformats.org/drawingml/2006/main">
          <a:off x="4895809" y="742945"/>
          <a:ext cx="314329" cy="2571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a</a:t>
          </a:r>
        </a:p>
      </cdr:txBody>
    </cdr:sp>
  </cdr:relSizeAnchor>
  <cdr:relSizeAnchor xmlns:cdr="http://schemas.openxmlformats.org/drawingml/2006/chartDrawing">
    <cdr:from>
      <cdr:x>0.25877</cdr:x>
      <cdr:y>0.12188</cdr:y>
    </cdr:from>
    <cdr:to>
      <cdr:x>0.28057</cdr:x>
      <cdr:y>0.1488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2600353" y="819182"/>
          <a:ext cx="219065" cy="1809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900"/>
            <a:t>a</a:t>
          </a:r>
        </a:p>
      </cdr:txBody>
    </cdr:sp>
  </cdr:relSizeAnchor>
  <cdr:relSizeAnchor xmlns:cdr="http://schemas.openxmlformats.org/drawingml/2006/chartDrawing">
    <cdr:from>
      <cdr:x>0.50521</cdr:x>
      <cdr:y>0.45347</cdr:y>
    </cdr:from>
    <cdr:to>
      <cdr:x>0.55355</cdr:x>
      <cdr:y>0.52857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5076819" y="3048017"/>
          <a:ext cx="485762" cy="504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 e</a:t>
          </a:r>
        </a:p>
      </cdr:txBody>
    </cdr:sp>
  </cdr:relSizeAnchor>
  <cdr:relSizeAnchor xmlns:cdr="http://schemas.openxmlformats.org/drawingml/2006/chartDrawing">
    <cdr:from>
      <cdr:x>0.52132</cdr:x>
      <cdr:y>0.36703</cdr:y>
    </cdr:from>
    <cdr:to>
      <cdr:x>0.53744</cdr:x>
      <cdr:y>0.41946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5238706" y="2466978"/>
          <a:ext cx="161988" cy="3524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3081</cdr:x>
      <cdr:y>0.27775</cdr:y>
    </cdr:from>
    <cdr:to>
      <cdr:x>0.55071</cdr:x>
      <cdr:y>0.31318</cdr:y>
    </cdr:to>
    <cdr:sp macro="" textlink="">
      <cdr:nvSpPr>
        <cdr:cNvPr id="50" name="CasellaDiTesto 49"/>
        <cdr:cNvSpPr txBox="1"/>
      </cdr:nvSpPr>
      <cdr:spPr>
        <a:xfrm xmlns:a="http://schemas.openxmlformats.org/drawingml/2006/main">
          <a:off x="5334006" y="1866897"/>
          <a:ext cx="199972" cy="2381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3649</cdr:x>
      <cdr:y>0.21115</cdr:y>
    </cdr:from>
    <cdr:to>
      <cdr:x>0.57157</cdr:x>
      <cdr:y>0.26783</cdr:y>
    </cdr:to>
    <cdr:sp macro="" textlink="">
      <cdr:nvSpPr>
        <cdr:cNvPr id="51" name="CasellaDiTesto 50"/>
        <cdr:cNvSpPr txBox="1"/>
      </cdr:nvSpPr>
      <cdr:spPr>
        <a:xfrm xmlns:a="http://schemas.openxmlformats.org/drawingml/2006/main">
          <a:off x="5391105" y="1419221"/>
          <a:ext cx="352514" cy="3809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4502</cdr:x>
      <cdr:y>0.11337</cdr:y>
    </cdr:from>
    <cdr:to>
      <cdr:x>0.56682</cdr:x>
      <cdr:y>0.14455</cdr:y>
    </cdr:to>
    <cdr:sp macro="" textlink="">
      <cdr:nvSpPr>
        <cdr:cNvPr id="52" name="CasellaDiTesto 51"/>
        <cdr:cNvSpPr txBox="1"/>
      </cdr:nvSpPr>
      <cdr:spPr>
        <a:xfrm xmlns:a="http://schemas.openxmlformats.org/drawingml/2006/main">
          <a:off x="5476878" y="762004"/>
          <a:ext cx="219065" cy="2095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6209</cdr:x>
      <cdr:y>0.33302</cdr:y>
    </cdr:from>
    <cdr:to>
      <cdr:x>0.61138</cdr:x>
      <cdr:y>0.39395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5648341" y="2238391"/>
          <a:ext cx="495309" cy="4095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  <a:r>
            <a:rPr lang="fr-FR" sz="1000" baseline="0"/>
            <a:t> </a:t>
          </a:r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8104</cdr:x>
      <cdr:y>0.28767</cdr:y>
    </cdr:from>
    <cdr:to>
      <cdr:x>0.59526</cdr:x>
      <cdr:y>0.32593</cdr:y>
    </cdr:to>
    <cdr:sp macro="" textlink="">
      <cdr:nvSpPr>
        <cdr:cNvPr id="54" name="CasellaDiTesto 53"/>
        <cdr:cNvSpPr txBox="1"/>
      </cdr:nvSpPr>
      <cdr:spPr>
        <a:xfrm xmlns:a="http://schemas.openxmlformats.org/drawingml/2006/main">
          <a:off x="5838825" y="1933574"/>
          <a:ext cx="142895" cy="2571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8483</cdr:x>
      <cdr:y>0.24232</cdr:y>
    </cdr:from>
    <cdr:to>
      <cdr:x>0.61137</cdr:x>
      <cdr:y>0.27775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5876932" y="1628775"/>
          <a:ext cx="266697" cy="2381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962</cdr:x>
      <cdr:y>0.07936</cdr:y>
    </cdr:from>
    <cdr:to>
      <cdr:x>0.62085</cdr:x>
      <cdr:y>0.12754</cdr:y>
    </cdr:to>
    <cdr:sp macro="" textlink="">
      <cdr:nvSpPr>
        <cdr:cNvPr id="56" name="CasellaDiTesto 55"/>
        <cdr:cNvSpPr txBox="1"/>
      </cdr:nvSpPr>
      <cdr:spPr>
        <a:xfrm xmlns:a="http://schemas.openxmlformats.org/drawingml/2006/main">
          <a:off x="5991187" y="533400"/>
          <a:ext cx="247705" cy="3238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0379</cdr:x>
      <cdr:y>0.1162</cdr:y>
    </cdr:from>
    <cdr:to>
      <cdr:x>0.63222</cdr:x>
      <cdr:y>0.15872</cdr:y>
    </cdr:to>
    <cdr:sp macro="" textlink="">
      <cdr:nvSpPr>
        <cdr:cNvPr id="57" name="CasellaDiTesto 56"/>
        <cdr:cNvSpPr txBox="1"/>
      </cdr:nvSpPr>
      <cdr:spPr>
        <a:xfrm xmlns:a="http://schemas.openxmlformats.org/drawingml/2006/main">
          <a:off x="6067435" y="781017"/>
          <a:ext cx="285690" cy="2857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2085</cdr:x>
      <cdr:y>0.54558</cdr:y>
    </cdr:from>
    <cdr:to>
      <cdr:x>0.6436</cdr:x>
      <cdr:y>0.58526</cdr:y>
    </cdr:to>
    <cdr:sp macro="" textlink="">
      <cdr:nvSpPr>
        <cdr:cNvPr id="58" name="CasellaDiTesto 57"/>
        <cdr:cNvSpPr txBox="1"/>
      </cdr:nvSpPr>
      <cdr:spPr>
        <a:xfrm xmlns:a="http://schemas.openxmlformats.org/drawingml/2006/main">
          <a:off x="6238856" y="3667123"/>
          <a:ext cx="228612" cy="2667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3033</cdr:x>
      <cdr:y>0.51015</cdr:y>
    </cdr:from>
    <cdr:to>
      <cdr:x>0.6474</cdr:x>
      <cdr:y>0.55408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6334076" y="3428992"/>
          <a:ext cx="171535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3697</cdr:x>
      <cdr:y>0.36845</cdr:y>
    </cdr:from>
    <cdr:to>
      <cdr:x>0.65498</cdr:x>
      <cdr:y>0.43505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6400822" y="2476496"/>
          <a:ext cx="180981" cy="4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4455</cdr:x>
      <cdr:y>0.29192</cdr:y>
    </cdr:from>
    <cdr:to>
      <cdr:x>0.66635</cdr:x>
      <cdr:y>0.34294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6476993" y="1962121"/>
          <a:ext cx="219065" cy="342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5118</cdr:x>
      <cdr:y>0.16297</cdr:y>
    </cdr:from>
    <cdr:to>
      <cdr:x>0.67488</cdr:x>
      <cdr:y>0.21256</cdr:y>
    </cdr:to>
    <cdr:sp macro="" textlink="">
      <cdr:nvSpPr>
        <cdr:cNvPr id="62" name="CasellaDiTesto 61"/>
        <cdr:cNvSpPr txBox="1"/>
      </cdr:nvSpPr>
      <cdr:spPr>
        <a:xfrm xmlns:a="http://schemas.openxmlformats.org/drawingml/2006/main">
          <a:off x="6543660" y="1095408"/>
          <a:ext cx="238158" cy="3333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1848</cdr:x>
      <cdr:y>0.12045</cdr:y>
    </cdr:from>
    <cdr:to>
      <cdr:x>0.74597</cdr:x>
      <cdr:y>0.1658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7219904" y="809631"/>
          <a:ext cx="276243" cy="3048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962</cdr:x>
      <cdr:y>0.41521</cdr:y>
    </cdr:from>
    <cdr:to>
      <cdr:x>0.71848</cdr:x>
      <cdr:y>0.45772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6829450" y="2790847"/>
          <a:ext cx="390499" cy="2857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 e</a:t>
          </a:r>
        </a:p>
      </cdr:txBody>
    </cdr:sp>
  </cdr:relSizeAnchor>
  <cdr:relSizeAnchor xmlns:cdr="http://schemas.openxmlformats.org/drawingml/2006/chartDrawing">
    <cdr:from>
      <cdr:x>0.69479</cdr:x>
      <cdr:y>0.31318</cdr:y>
    </cdr:from>
    <cdr:to>
      <cdr:x>0.71374</cdr:x>
      <cdr:y>0.37554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6981870" y="2105000"/>
          <a:ext cx="190426" cy="4191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0237</cdr:x>
      <cdr:y>0.23949</cdr:y>
    </cdr:from>
    <cdr:to>
      <cdr:x>0.72701</cdr:x>
      <cdr:y>0.26925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7058062" y="1609734"/>
          <a:ext cx="247604" cy="2000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0901</cdr:x>
      <cdr:y>0.17855</cdr:y>
    </cdr:from>
    <cdr:to>
      <cdr:x>0.73555</cdr:x>
      <cdr:y>0.22248</cdr:y>
    </cdr:to>
    <cdr:sp macro="" textlink="">
      <cdr:nvSpPr>
        <cdr:cNvPr id="67" name="CasellaDiTesto 66"/>
        <cdr:cNvSpPr txBox="1"/>
      </cdr:nvSpPr>
      <cdr:spPr>
        <a:xfrm xmlns:a="http://schemas.openxmlformats.org/drawingml/2006/main">
          <a:off x="7124750" y="1200148"/>
          <a:ext cx="266697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7061</cdr:x>
      <cdr:y>0.11904</cdr:y>
    </cdr:from>
    <cdr:to>
      <cdr:x>0.80569</cdr:x>
      <cdr:y>0.1658</cdr:y>
    </cdr:to>
    <cdr:sp macro="" textlink="">
      <cdr:nvSpPr>
        <cdr:cNvPr id="68" name="CasellaDiTesto 67"/>
        <cdr:cNvSpPr txBox="1"/>
      </cdr:nvSpPr>
      <cdr:spPr>
        <a:xfrm xmlns:a="http://schemas.openxmlformats.org/drawingml/2006/main">
          <a:off x="7743801" y="800100"/>
          <a:ext cx="352449" cy="3143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73555</cdr:x>
      <cdr:y>0.49174</cdr:y>
    </cdr:from>
    <cdr:to>
      <cdr:x>0.77346</cdr:x>
      <cdr:y>0.54559</cdr:y>
    </cdr:to>
    <cdr:sp macro="" textlink="">
      <cdr:nvSpPr>
        <cdr:cNvPr id="69" name="CasellaDiTesto 68"/>
        <cdr:cNvSpPr txBox="1"/>
      </cdr:nvSpPr>
      <cdr:spPr>
        <a:xfrm xmlns:a="http://schemas.openxmlformats.org/drawingml/2006/main">
          <a:off x="7391404" y="3305189"/>
          <a:ext cx="380953" cy="361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75355</cdr:x>
      <cdr:y>0.38971</cdr:y>
    </cdr:from>
    <cdr:to>
      <cdr:x>0.76967</cdr:x>
      <cdr:y>0.42939</cdr:y>
    </cdr:to>
    <cdr:sp macro="" textlink="">
      <cdr:nvSpPr>
        <cdr:cNvPr id="70" name="CasellaDiTesto 69"/>
        <cdr:cNvSpPr txBox="1"/>
      </cdr:nvSpPr>
      <cdr:spPr>
        <a:xfrm xmlns:a="http://schemas.openxmlformats.org/drawingml/2006/main">
          <a:off x="7572327" y="2619399"/>
          <a:ext cx="161988" cy="2667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6019</cdr:x>
      <cdr:y>0.31035</cdr:y>
    </cdr:from>
    <cdr:to>
      <cdr:x>0.78009</cdr:x>
      <cdr:y>0.36278</cdr:y>
    </cdr:to>
    <cdr:sp macro="" textlink="">
      <cdr:nvSpPr>
        <cdr:cNvPr id="71" name="CasellaDiTesto 70"/>
        <cdr:cNvSpPr txBox="1"/>
      </cdr:nvSpPr>
      <cdr:spPr>
        <a:xfrm xmlns:a="http://schemas.openxmlformats.org/drawingml/2006/main">
          <a:off x="7639088" y="2085996"/>
          <a:ext cx="199972" cy="3524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2559</cdr:x>
      <cdr:y>0.14738</cdr:y>
    </cdr:from>
    <cdr:to>
      <cdr:x>0.84929</cdr:x>
      <cdr:y>0.18139</cdr:y>
    </cdr:to>
    <cdr:sp macro="" textlink="">
      <cdr:nvSpPr>
        <cdr:cNvPr id="72" name="CasellaDiTesto 71"/>
        <cdr:cNvSpPr txBox="1"/>
      </cdr:nvSpPr>
      <cdr:spPr>
        <a:xfrm xmlns:a="http://schemas.openxmlformats.org/drawingml/2006/main">
          <a:off x="8296268" y="990625"/>
          <a:ext cx="238159" cy="2285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3318</cdr:x>
      <cdr:y>0.1162</cdr:y>
    </cdr:from>
    <cdr:to>
      <cdr:x>0.85687</cdr:x>
      <cdr:y>0.1658</cdr:y>
    </cdr:to>
    <cdr:sp macro="" textlink="">
      <cdr:nvSpPr>
        <cdr:cNvPr id="73" name="CasellaDiTesto 72"/>
        <cdr:cNvSpPr txBox="1"/>
      </cdr:nvSpPr>
      <cdr:spPr>
        <a:xfrm xmlns:a="http://schemas.openxmlformats.org/drawingml/2006/main">
          <a:off x="8372495" y="781029"/>
          <a:ext cx="238058" cy="3333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9337</cdr:x>
      <cdr:y>0.57392</cdr:y>
    </cdr:from>
    <cdr:to>
      <cdr:x>0.85213</cdr:x>
      <cdr:y>0.63061</cdr:y>
    </cdr:to>
    <cdr:sp macro="" textlink="">
      <cdr:nvSpPr>
        <cdr:cNvPr id="74" name="CasellaDiTesto 73"/>
        <cdr:cNvSpPr txBox="1"/>
      </cdr:nvSpPr>
      <cdr:spPr>
        <a:xfrm xmlns:a="http://schemas.openxmlformats.org/drawingml/2006/main">
          <a:off x="7972458" y="3857615"/>
          <a:ext cx="590472" cy="3810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80947</cdr:x>
      <cdr:y>0.40104</cdr:y>
    </cdr:from>
    <cdr:to>
      <cdr:x>0.82748</cdr:x>
      <cdr:y>0.44213</cdr:y>
    </cdr:to>
    <cdr:sp macro="" textlink="">
      <cdr:nvSpPr>
        <cdr:cNvPr id="75" name="CasellaDiTesto 74"/>
        <cdr:cNvSpPr txBox="1"/>
      </cdr:nvSpPr>
      <cdr:spPr>
        <a:xfrm xmlns:a="http://schemas.openxmlformats.org/drawingml/2006/main">
          <a:off x="8134303" y="2695593"/>
          <a:ext cx="180980" cy="2761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1991</cdr:x>
      <cdr:y>0.32452</cdr:y>
    </cdr:from>
    <cdr:to>
      <cdr:x>0.83602</cdr:x>
      <cdr:y>0.38687</cdr:y>
    </cdr:to>
    <cdr:sp macro="" textlink="">
      <cdr:nvSpPr>
        <cdr:cNvPr id="76" name="CasellaDiTesto 75"/>
        <cdr:cNvSpPr txBox="1"/>
      </cdr:nvSpPr>
      <cdr:spPr>
        <a:xfrm xmlns:a="http://schemas.openxmlformats.org/drawingml/2006/main">
          <a:off x="8239170" y="2181248"/>
          <a:ext cx="161888" cy="4190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91</cdr:x>
      <cdr:y>0.11621</cdr:y>
    </cdr:from>
    <cdr:to>
      <cdr:x>0.91375</cdr:x>
      <cdr:y>0.15588</cdr:y>
    </cdr:to>
    <cdr:sp macro="" textlink="">
      <cdr:nvSpPr>
        <cdr:cNvPr id="78" name="CasellaDiTesto 77"/>
        <cdr:cNvSpPr txBox="1"/>
      </cdr:nvSpPr>
      <cdr:spPr>
        <a:xfrm xmlns:a="http://schemas.openxmlformats.org/drawingml/2006/main">
          <a:off x="8953506" y="781082"/>
          <a:ext cx="228612" cy="2666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5118</cdr:x>
      <cdr:y>0.4804</cdr:y>
    </cdr:from>
    <cdr:to>
      <cdr:x>0.89289</cdr:x>
      <cdr:y>0.53708</cdr:y>
    </cdr:to>
    <cdr:sp macro="" textlink="">
      <cdr:nvSpPr>
        <cdr:cNvPr id="79" name="CasellaDiTesto 78"/>
        <cdr:cNvSpPr txBox="1"/>
      </cdr:nvSpPr>
      <cdr:spPr>
        <a:xfrm xmlns:a="http://schemas.openxmlformats.org/drawingml/2006/main">
          <a:off x="8553405" y="3228976"/>
          <a:ext cx="419139" cy="3809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 e</a:t>
          </a:r>
        </a:p>
      </cdr:txBody>
    </cdr:sp>
  </cdr:relSizeAnchor>
  <cdr:relSizeAnchor xmlns:cdr="http://schemas.openxmlformats.org/drawingml/2006/chartDrawing">
    <cdr:from>
      <cdr:x>0.8673</cdr:x>
      <cdr:y>0.39679</cdr:y>
    </cdr:from>
    <cdr:to>
      <cdr:x>0.88341</cdr:x>
      <cdr:y>0.44213</cdr:y>
    </cdr:to>
    <cdr:sp macro="" textlink="">
      <cdr:nvSpPr>
        <cdr:cNvPr id="80" name="CasellaDiTesto 79"/>
        <cdr:cNvSpPr txBox="1"/>
      </cdr:nvSpPr>
      <cdr:spPr>
        <a:xfrm xmlns:a="http://schemas.openxmlformats.org/drawingml/2006/main">
          <a:off x="8715393" y="2667024"/>
          <a:ext cx="161887" cy="3047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7678</cdr:x>
      <cdr:y>0.28342</cdr:y>
    </cdr:from>
    <cdr:to>
      <cdr:x>0.90522</cdr:x>
      <cdr:y>0.3231</cdr:y>
    </cdr:to>
    <cdr:sp macro="" textlink="">
      <cdr:nvSpPr>
        <cdr:cNvPr id="81" name="CasellaDiTesto 80"/>
        <cdr:cNvSpPr txBox="1"/>
      </cdr:nvSpPr>
      <cdr:spPr>
        <a:xfrm xmlns:a="http://schemas.openxmlformats.org/drawingml/2006/main">
          <a:off x="8810614" y="1904978"/>
          <a:ext cx="285790" cy="2667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8246</cdr:x>
      <cdr:y>0.17005</cdr:y>
    </cdr:from>
    <cdr:to>
      <cdr:x>0.90806</cdr:x>
      <cdr:y>0.21256</cdr:y>
    </cdr:to>
    <cdr:sp macro="" textlink="">
      <cdr:nvSpPr>
        <cdr:cNvPr id="82" name="CasellaDiTesto 81"/>
        <cdr:cNvSpPr txBox="1"/>
      </cdr:nvSpPr>
      <cdr:spPr>
        <a:xfrm xmlns:a="http://schemas.openxmlformats.org/drawingml/2006/main">
          <a:off x="8867734" y="1143005"/>
          <a:ext cx="257251" cy="285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5364088" y="149263"/>
            <a:ext cx="28801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smtClean="0"/>
              <a:t>Honokiol</a:t>
            </a:r>
            <a:r>
              <a:rPr lang="en-GB" dirty="0" smtClean="0"/>
              <a:t> </a:t>
            </a:r>
            <a:r>
              <a:rPr lang="en-GB" b="1" dirty="0"/>
              <a:t>4ʹ-</a:t>
            </a:r>
            <a:r>
              <a:rPr lang="en-GB" b="1" dirty="0" err="1"/>
              <a:t>monoacetate</a:t>
            </a:r>
            <a:r>
              <a:rPr lang="en-GB" b="1" dirty="0"/>
              <a:t> </a:t>
            </a:r>
            <a:r>
              <a:rPr lang="en-GB" b="1" dirty="0" smtClean="0"/>
              <a:t>6</a:t>
            </a:r>
            <a:endParaRPr lang="en-GB" b="1" dirty="0"/>
          </a:p>
        </p:txBody>
      </p:sp>
      <p:graphicFrame>
        <p:nvGraphicFramePr>
          <p:cNvPr id="5" name="Grafico 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4868383"/>
              </p:ext>
            </p:extLst>
          </p:nvPr>
        </p:nvGraphicFramePr>
        <p:xfrm>
          <a:off x="0" y="533669"/>
          <a:ext cx="9200901" cy="6313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10657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</TotalTime>
  <Words>102</Words>
  <Application>Microsoft Office PowerPoint</Application>
  <PresentationFormat>Presentazione su schermo 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7:58Z</dcterms:modified>
</cp:coreProperties>
</file>